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A238CA-30D3-4053-BB1A-697B5B909FC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402145-CD38-401A-A837-58DFCEC80BA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968A52-D21D-4E11-9395-390F35B37D8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B3B073-4D02-433A-8D2B-2E6245DB51D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4FA384-F19D-40C2-A732-5D2C3BBCA3B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F50296-8F8F-48D5-9334-501DAD01F4D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31D7CF-80BF-486B-A280-A42F2F1414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396CF1-0822-4149-9CFF-59ADBC48220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7A7C58-0AF5-4D8C-BB55-AD757F1C55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232F8A-0E5B-4CEE-A46C-CDA499C773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97328D-9CDF-484C-B18B-0F5082D071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93B65B-8340-4180-A994-E4CA523324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3680C2E-59CC-4B47-928F-6109C65DA0F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pecificity of sequences and higher taxonomic groups for environment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Content Placeholder 3" descr=""/>
          <p:cNvPicPr/>
          <p:nvPr/>
        </p:nvPicPr>
        <p:blipFill>
          <a:blip r:embed="rId1"/>
          <a:stretch/>
        </p:blipFill>
        <p:spPr>
          <a:xfrm>
            <a:off x="1371600" y="1959120"/>
            <a:ext cx="6400800" cy="29700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5" descr=""/>
          <p:cNvPicPr/>
          <p:nvPr/>
        </p:nvPicPr>
        <p:blipFill>
          <a:blip r:embed="rId2"/>
          <a:stretch/>
        </p:blipFill>
        <p:spPr>
          <a:xfrm>
            <a:off x="6985080" y="6222960"/>
            <a:ext cx="1333440" cy="279360"/>
          </a:xfrm>
          <a:prstGeom prst="rect">
            <a:avLst/>
          </a:prstGeom>
          <a:ln w="0">
            <a:noFill/>
          </a:ln>
        </p:spPr>
      </p:pic>
      <p:sp>
        <p:nvSpPr>
          <p:cNvPr id="44" name="Title 1"/>
          <p:cNvSpPr/>
          <p:nvPr/>
        </p:nvSpPr>
        <p:spPr>
          <a:xfrm>
            <a:off x="444600" y="5851440"/>
            <a:ext cx="8229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L R Thompson </a:t>
            </a:r>
            <a:r>
              <a:rPr b="0" i="1" lang="fr-FR" sz="1200" spc="-1" strike="noStrike">
                <a:solidFill>
                  <a:srgbClr val="000000"/>
                </a:solidFill>
                <a:latin typeface="Arial"/>
              </a:rPr>
              <a:t>et al. Nature</a:t>
            </a: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 1–9 (2017) doi:10.1038/nature2462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10-30T05:53:58Z</dcterms:created>
  <dc:creator>ravikumar.n</dc:creator>
  <dc:description/>
  <dc:language>en-US</dc:language>
  <cp:lastModifiedBy>ravikumar.n</cp:lastModifiedBy>
  <dcterms:modified xsi:type="dcterms:W3CDTF">2017-10-30T05:54:03Z</dcterms:modified>
  <cp:revision>1</cp:revision>
  <dc:subject/>
  <dc:title>Specificity of sequences and higher taxonomic groups for environment</dc:title>
</cp:coreProperties>
</file>